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7" r:id="rId2"/>
  </p:sldIdLst>
  <p:sldSz cx="6858000" cy="9906000" type="A4"/>
  <p:notesSz cx="6985000" cy="92837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64" userDrawn="1">
          <p15:clr>
            <a:srgbClr val="A4A3A4"/>
          </p15:clr>
        </p15:guide>
        <p15:guide id="2" pos="336" userDrawn="1">
          <p15:clr>
            <a:srgbClr val="A4A3A4"/>
          </p15:clr>
        </p15:guide>
        <p15:guide id="3" pos="3984" userDrawn="1">
          <p15:clr>
            <a:srgbClr val="A4A3A4"/>
          </p15:clr>
        </p15:guide>
        <p15:guide id="4" pos="3672" userDrawn="1">
          <p15:clr>
            <a:srgbClr val="A4A3A4"/>
          </p15:clr>
        </p15:guide>
        <p15:guide id="5" orient="horz" pos="32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4754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4120" y="-208"/>
      </p:cViewPr>
      <p:guideLst>
        <p:guide orient="horz" pos="264"/>
        <p:guide pos="336"/>
        <p:guide pos="3984"/>
        <p:guide pos="3672"/>
        <p:guide orient="horz" pos="32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/smb-isi1.lerner.ccf.org\engclab\LAB_MEMBER_CENTRAL\Ritika%20Jaini\Maternal%20Inflammation%20in%20autism\Nanostring\Brain%20Glial%20Panel\Paired%20ratio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021594781995535"/>
          <c:y val="5.3268774964934526E-2"/>
          <c:w val="0.85859149136208723"/>
          <c:h val="0.83196590525194247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4!$B$56</c:f>
              <c:strCache>
                <c:ptCount val="1"/>
                <c:pt idx="0">
                  <c:v>WT-WT-P40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Sheet4!$G$57:$G$64</c:f>
                <c:numCache>
                  <c:formatCode>General</c:formatCode>
                  <c:ptCount val="8"/>
                  <c:pt idx="0">
                    <c:v>39.33</c:v>
                  </c:pt>
                  <c:pt idx="1">
                    <c:v>26.21</c:v>
                  </c:pt>
                  <c:pt idx="2">
                    <c:v>43.7</c:v>
                  </c:pt>
                  <c:pt idx="3">
                    <c:v>17.96</c:v>
                  </c:pt>
                  <c:pt idx="4">
                    <c:v>6.84</c:v>
                  </c:pt>
                  <c:pt idx="5">
                    <c:v>4.21</c:v>
                  </c:pt>
                  <c:pt idx="6">
                    <c:v>0.4</c:v>
                  </c:pt>
                  <c:pt idx="7">
                    <c:v>6.27</c:v>
                  </c:pt>
                </c:numCache>
              </c:numRef>
            </c:plus>
            <c:spPr>
              <a:solidFill>
                <a:schemeClr val="tx1"/>
              </a:solidFill>
              <a:ln>
                <a:solidFill>
                  <a:schemeClr val="tx1"/>
                </a:solidFill>
              </a:ln>
              <a:effectLst/>
            </c:spPr>
          </c:errBars>
          <c:cat>
            <c:strRef>
              <c:f>Sheet4!$A$57:$A$64</c:f>
              <c:strCache>
                <c:ptCount val="8"/>
                <c:pt idx="0">
                  <c:v>C1qb</c:v>
                </c:pt>
                <c:pt idx="1">
                  <c:v>C1qc</c:v>
                </c:pt>
                <c:pt idx="2">
                  <c:v>Klk6</c:v>
                </c:pt>
                <c:pt idx="3">
                  <c:v>Aif1</c:v>
                </c:pt>
                <c:pt idx="4">
                  <c:v>Iigp1</c:v>
                </c:pt>
                <c:pt idx="5">
                  <c:v>Stab1</c:v>
                </c:pt>
                <c:pt idx="6">
                  <c:v>Ticam1</c:v>
                </c:pt>
                <c:pt idx="7">
                  <c:v>Cd33</c:v>
                </c:pt>
              </c:strCache>
            </c:strRef>
          </c:cat>
          <c:val>
            <c:numRef>
              <c:f>Sheet4!$B$57:$B$64</c:f>
              <c:numCache>
                <c:formatCode>General</c:formatCode>
                <c:ptCount val="8"/>
                <c:pt idx="0">
                  <c:v>287.18</c:v>
                </c:pt>
                <c:pt idx="1">
                  <c:v>228.47</c:v>
                </c:pt>
                <c:pt idx="2">
                  <c:v>264.79000000000002</c:v>
                </c:pt>
                <c:pt idx="3">
                  <c:v>104.61</c:v>
                </c:pt>
                <c:pt idx="4">
                  <c:v>31.83</c:v>
                </c:pt>
                <c:pt idx="5">
                  <c:v>24.3</c:v>
                </c:pt>
                <c:pt idx="6">
                  <c:v>20.2</c:v>
                </c:pt>
                <c:pt idx="7">
                  <c:v>27.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957-9B49-95BC-C7EE0865DA6D}"/>
            </c:ext>
          </c:extLst>
        </c:ser>
        <c:ser>
          <c:idx val="1"/>
          <c:order val="1"/>
          <c:tx>
            <c:strRef>
              <c:f>Sheet4!$C$56</c:f>
              <c:strCache>
                <c:ptCount val="1"/>
                <c:pt idx="0">
                  <c:v>WT-HET-P40</c:v>
                </c:pt>
              </c:strCache>
            </c:strRef>
          </c:tx>
          <c:spPr>
            <a:solidFill>
              <a:srgbClr val="ED7D31"/>
            </a:solidFill>
            <a:ln w="25400">
              <a:noFill/>
            </a:ln>
          </c:spPr>
          <c:invertIfNegative val="0"/>
          <c:errBars>
            <c:errBarType val="plus"/>
            <c:errValType val="fixedVal"/>
            <c:noEndCap val="0"/>
            <c:val val="5"/>
            <c:spPr>
              <a:ln w="635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4!$A$57:$A$64</c:f>
              <c:strCache>
                <c:ptCount val="8"/>
                <c:pt idx="0">
                  <c:v>C1qb</c:v>
                </c:pt>
                <c:pt idx="1">
                  <c:v>C1qc</c:v>
                </c:pt>
                <c:pt idx="2">
                  <c:v>Klk6</c:v>
                </c:pt>
                <c:pt idx="3">
                  <c:v>Aif1</c:v>
                </c:pt>
                <c:pt idx="4">
                  <c:v>Iigp1</c:v>
                </c:pt>
                <c:pt idx="5">
                  <c:v>Stab1</c:v>
                </c:pt>
                <c:pt idx="6">
                  <c:v>Ticam1</c:v>
                </c:pt>
                <c:pt idx="7">
                  <c:v>Cd33</c:v>
                </c:pt>
              </c:strCache>
            </c:strRef>
          </c:cat>
          <c:val>
            <c:numRef>
              <c:f>Sheet4!$C$57:$C$64</c:f>
              <c:numCache>
                <c:formatCode>General</c:formatCode>
                <c:ptCount val="8"/>
                <c:pt idx="0">
                  <c:v>379.95</c:v>
                </c:pt>
                <c:pt idx="1">
                  <c:v>299.27</c:v>
                </c:pt>
                <c:pt idx="2">
                  <c:v>395.24</c:v>
                </c:pt>
                <c:pt idx="3">
                  <c:v>135.71</c:v>
                </c:pt>
                <c:pt idx="4">
                  <c:v>30.43</c:v>
                </c:pt>
                <c:pt idx="5">
                  <c:v>25.58</c:v>
                </c:pt>
                <c:pt idx="6">
                  <c:v>27.35</c:v>
                </c:pt>
                <c:pt idx="7">
                  <c:v>39.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957-9B49-95BC-C7EE0865DA6D}"/>
            </c:ext>
          </c:extLst>
        </c:ser>
        <c:ser>
          <c:idx val="2"/>
          <c:order val="2"/>
          <c:tx>
            <c:strRef>
              <c:f>Sheet4!$D$56</c:f>
              <c:strCache>
                <c:ptCount val="1"/>
                <c:pt idx="0">
                  <c:v>HET-WT-P40</c:v>
                </c:pt>
              </c:strCache>
            </c:strRef>
          </c:tx>
          <c:spPr>
            <a:solidFill>
              <a:srgbClr val="A5A5A5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4!$I$57:$I$64</c:f>
                <c:numCache>
                  <c:formatCode>General</c:formatCode>
                  <c:ptCount val="8"/>
                  <c:pt idx="0">
                    <c:v>6.48</c:v>
                  </c:pt>
                  <c:pt idx="1">
                    <c:v>48.02</c:v>
                  </c:pt>
                  <c:pt idx="2">
                    <c:v>88.48</c:v>
                  </c:pt>
                  <c:pt idx="3">
                    <c:v>14.54</c:v>
                  </c:pt>
                  <c:pt idx="4">
                    <c:v>8.7799999999999994</c:v>
                  </c:pt>
                  <c:pt idx="5">
                    <c:v>0.83</c:v>
                  </c:pt>
                  <c:pt idx="6">
                    <c:v>0.83</c:v>
                  </c:pt>
                  <c:pt idx="7">
                    <c:v>4.01</c:v>
                  </c:pt>
                </c:numCache>
              </c:numRef>
            </c:plus>
            <c:spPr>
              <a:ln w="635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4!$A$57:$A$64</c:f>
              <c:strCache>
                <c:ptCount val="8"/>
                <c:pt idx="0">
                  <c:v>C1qb</c:v>
                </c:pt>
                <c:pt idx="1">
                  <c:v>C1qc</c:v>
                </c:pt>
                <c:pt idx="2">
                  <c:v>Klk6</c:v>
                </c:pt>
                <c:pt idx="3">
                  <c:v>Aif1</c:v>
                </c:pt>
                <c:pt idx="4">
                  <c:v>Iigp1</c:v>
                </c:pt>
                <c:pt idx="5">
                  <c:v>Stab1</c:v>
                </c:pt>
                <c:pt idx="6">
                  <c:v>Ticam1</c:v>
                </c:pt>
                <c:pt idx="7">
                  <c:v>Cd33</c:v>
                </c:pt>
              </c:strCache>
            </c:strRef>
          </c:cat>
          <c:val>
            <c:numRef>
              <c:f>Sheet4!$D$57:$D$64</c:f>
              <c:numCache>
                <c:formatCode>General</c:formatCode>
                <c:ptCount val="8"/>
                <c:pt idx="0">
                  <c:v>322.95</c:v>
                </c:pt>
                <c:pt idx="1">
                  <c:v>268.83999999999997</c:v>
                </c:pt>
                <c:pt idx="2">
                  <c:v>272.05</c:v>
                </c:pt>
                <c:pt idx="3">
                  <c:v>127.44</c:v>
                </c:pt>
                <c:pt idx="4">
                  <c:v>45.56</c:v>
                </c:pt>
                <c:pt idx="5">
                  <c:v>20.399999999999999</c:v>
                </c:pt>
                <c:pt idx="6">
                  <c:v>20.399999999999999</c:v>
                </c:pt>
                <c:pt idx="7">
                  <c:v>30.0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957-9B49-95BC-C7EE0865DA6D}"/>
            </c:ext>
          </c:extLst>
        </c:ser>
        <c:ser>
          <c:idx val="3"/>
          <c:order val="3"/>
          <c:tx>
            <c:strRef>
              <c:f>Sheet4!$E$56</c:f>
              <c:strCache>
                <c:ptCount val="1"/>
                <c:pt idx="0">
                  <c:v>HET-HET-P40</c:v>
                </c:pt>
              </c:strCache>
            </c:strRef>
          </c:tx>
          <c:spPr>
            <a:solidFill>
              <a:srgbClr val="FFC000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Sheet4!$J$57:$J$64</c:f>
                <c:numCache>
                  <c:formatCode>General</c:formatCode>
                  <c:ptCount val="8"/>
                  <c:pt idx="0">
                    <c:v>30.71</c:v>
                  </c:pt>
                  <c:pt idx="1">
                    <c:v>8.7200000000000006</c:v>
                  </c:pt>
                  <c:pt idx="2">
                    <c:v>151</c:v>
                  </c:pt>
                  <c:pt idx="3">
                    <c:v>13.82</c:v>
                  </c:pt>
                  <c:pt idx="4">
                    <c:v>5.55</c:v>
                  </c:pt>
                  <c:pt idx="5">
                    <c:v>4.67</c:v>
                  </c:pt>
                  <c:pt idx="6">
                    <c:v>0.31</c:v>
                  </c:pt>
                  <c:pt idx="7">
                    <c:v>16.41</c:v>
                  </c:pt>
                </c:numCache>
              </c:numRef>
            </c:plus>
            <c:spPr>
              <a:ln w="6350">
                <a:solidFill>
                  <a:srgbClr val="000000"/>
                </a:solidFill>
                <a:prstDash val="solid"/>
              </a:ln>
            </c:spPr>
          </c:errBars>
          <c:cat>
            <c:strRef>
              <c:f>Sheet4!$A$57:$A$64</c:f>
              <c:strCache>
                <c:ptCount val="8"/>
                <c:pt idx="0">
                  <c:v>C1qb</c:v>
                </c:pt>
                <c:pt idx="1">
                  <c:v>C1qc</c:v>
                </c:pt>
                <c:pt idx="2">
                  <c:v>Klk6</c:v>
                </c:pt>
                <c:pt idx="3">
                  <c:v>Aif1</c:v>
                </c:pt>
                <c:pt idx="4">
                  <c:v>Iigp1</c:v>
                </c:pt>
                <c:pt idx="5">
                  <c:v>Stab1</c:v>
                </c:pt>
                <c:pt idx="6">
                  <c:v>Ticam1</c:v>
                </c:pt>
                <c:pt idx="7">
                  <c:v>Cd33</c:v>
                </c:pt>
              </c:strCache>
            </c:strRef>
          </c:cat>
          <c:val>
            <c:numRef>
              <c:f>Sheet4!$E$57:$E$64</c:f>
              <c:numCache>
                <c:formatCode>General</c:formatCode>
                <c:ptCount val="8"/>
                <c:pt idx="0">
                  <c:v>427.42</c:v>
                </c:pt>
                <c:pt idx="1">
                  <c:v>341.96</c:v>
                </c:pt>
                <c:pt idx="2">
                  <c:v>333.95</c:v>
                </c:pt>
                <c:pt idx="3">
                  <c:v>143.36000000000001</c:v>
                </c:pt>
                <c:pt idx="4">
                  <c:v>30.64</c:v>
                </c:pt>
                <c:pt idx="5">
                  <c:v>30.55</c:v>
                </c:pt>
                <c:pt idx="6">
                  <c:v>26.93</c:v>
                </c:pt>
                <c:pt idx="7">
                  <c:v>36.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957-9B49-95BC-C7EE0865DA6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938272"/>
        <c:axId val="64937096"/>
      </c:barChart>
      <c:catAx>
        <c:axId val="649382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937096"/>
        <c:crosses val="autoZero"/>
        <c:auto val="1"/>
        <c:lblAlgn val="ctr"/>
        <c:lblOffset val="100"/>
        <c:noMultiLvlLbl val="0"/>
      </c:catAx>
      <c:valAx>
        <c:axId val="64937096"/>
        <c:scaling>
          <c:orientation val="minMax"/>
          <c:max val="5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70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ranscript</a:t>
                </a:r>
                <a:r>
                  <a:rPr lang="en-US" sz="7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 Count</a:t>
                </a:r>
                <a:endParaRPr lang="en-US" sz="700">
                  <a:solidFill>
                    <a:sysClr val="windowText" lastClr="000000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1.1478735061029992E-2"/>
              <c:y val="0.30104478465615525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6493827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2783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23550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78277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4798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70353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45956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17009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39490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22580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71932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4236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7F2F01-4441-42A0-85DD-18DC6052AECF}" type="datetimeFigureOut">
              <a:rPr lang="en-US" smtClean="0"/>
              <a:t>3/10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01BAE7-EC38-49D3-A747-FF9DECBFAF4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963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chart" Target="../charts/chart1.xml"/><Relationship Id="rId7" Type="http://schemas.openxmlformats.org/officeDocument/2006/relationships/image" Target="../media/image5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2020" y="5011497"/>
            <a:ext cx="5905609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. Quantification of fetal brain pathology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-E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Quantification of blood brain barrier markers and neuronal markers for IHC stains in figures 3 and 4. 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F)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Nanostring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glial panel gene expression at P40 showing glial cell specific gene expression in Pup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m3m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=4) compared to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Pup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=4) derived from Mom</a:t>
            </a:r>
            <a:r>
              <a:rPr lang="en-US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m3m4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=4) vs 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Mom</a:t>
            </a:r>
            <a:r>
              <a:rPr lang="en-US" sz="1200" baseline="30000" dirty="0" err="1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(n=4). </a:t>
            </a:r>
            <a:r>
              <a:rPr lang="en-US" sz="1200" dirty="0"/>
              <a:t>Two tailed t-test; *p&lt;0.05; **p&lt;0.01.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oup 9">
            <a:extLst>
              <a:ext uri="{FF2B5EF4-FFF2-40B4-BE49-F238E27FC236}">
                <a16:creationId xmlns:a16="http://schemas.microsoft.com/office/drawing/2014/main" id="{DD4050D6-85D3-5044-8423-DCE0B8A046C8}"/>
              </a:ext>
            </a:extLst>
          </p:cNvPr>
          <p:cNvGrpSpPr/>
          <p:nvPr/>
        </p:nvGrpSpPr>
        <p:grpSpPr>
          <a:xfrm>
            <a:off x="677234" y="2993499"/>
            <a:ext cx="3520563" cy="2047944"/>
            <a:chOff x="570152" y="2885413"/>
            <a:chExt cx="3637369" cy="2004560"/>
          </a:xfrm>
        </p:grpSpPr>
        <p:graphicFrame>
          <p:nvGraphicFramePr>
            <p:cNvPr id="12" name="Chart 1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945459584"/>
                </p:ext>
              </p:extLst>
            </p:nvPr>
          </p:nvGraphicFramePr>
          <p:xfrm>
            <a:off x="570152" y="2885413"/>
            <a:ext cx="3637369" cy="200456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pSp>
          <p:nvGrpSpPr>
            <p:cNvPr id="4" name="Group 3"/>
            <p:cNvGrpSpPr/>
            <p:nvPr/>
          </p:nvGrpSpPr>
          <p:grpSpPr>
            <a:xfrm>
              <a:off x="2846340" y="3273827"/>
              <a:ext cx="996952" cy="505508"/>
              <a:chOff x="4829384" y="2402171"/>
              <a:chExt cx="996952" cy="505508"/>
            </a:xfrm>
          </p:grpSpPr>
          <p:sp>
            <p:nvSpPr>
              <p:cNvPr id="13" name="Rectangle 12"/>
              <p:cNvSpPr/>
              <p:nvPr/>
            </p:nvSpPr>
            <p:spPr>
              <a:xfrm>
                <a:off x="4829388" y="2475819"/>
                <a:ext cx="69414" cy="63500"/>
              </a:xfrm>
              <a:prstGeom prst="rect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Rectangle 13"/>
              <p:cNvSpPr/>
              <p:nvPr/>
            </p:nvSpPr>
            <p:spPr>
              <a:xfrm>
                <a:off x="4829387" y="2570476"/>
                <a:ext cx="69414" cy="63500"/>
              </a:xfrm>
              <a:prstGeom prst="rect">
                <a:avLst/>
              </a:prstGeom>
              <a:solidFill>
                <a:schemeClr val="accent2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4852993" y="2402171"/>
                <a:ext cx="825867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Mom</a:t>
                </a:r>
                <a:r>
                  <a:rPr lang="en-US" sz="7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7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-Fetus</a:t>
                </a:r>
                <a:r>
                  <a:rPr lang="en-US" sz="700" baseline="30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endParaRPr lang="en-US" sz="700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4864094" y="2507569"/>
                <a:ext cx="89960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om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Fetus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3m4</a:t>
                </a:r>
              </a:p>
            </p:txBody>
          </p:sp>
          <p:sp>
            <p:nvSpPr>
              <p:cNvPr id="17" name="Rectangle 16"/>
              <p:cNvSpPr/>
              <p:nvPr/>
            </p:nvSpPr>
            <p:spPr>
              <a:xfrm>
                <a:off x="4830958" y="2667673"/>
                <a:ext cx="69414" cy="63500"/>
              </a:xfrm>
              <a:prstGeom prst="rect">
                <a:avLst/>
              </a:prstGeom>
              <a:solidFill>
                <a:schemeClr val="bg1">
                  <a:lumMod val="65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Rectangle 17"/>
              <p:cNvSpPr/>
              <p:nvPr/>
            </p:nvSpPr>
            <p:spPr>
              <a:xfrm>
                <a:off x="4829384" y="2764092"/>
                <a:ext cx="69414" cy="63500"/>
              </a:xfrm>
              <a:prstGeom prst="rect">
                <a:avLst/>
              </a:prstGeom>
              <a:solidFill>
                <a:schemeClr val="accent4">
                  <a:lumMod val="60000"/>
                  <a:lumOff val="40000"/>
                </a:schemeClr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4860151" y="2610984"/>
                <a:ext cx="899605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om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3m4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Fetus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WT</a:t>
                </a:r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4852993" y="2707624"/>
                <a:ext cx="973343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Mom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3m4</a:t>
                </a:r>
                <a:r>
                  <a:rPr lang="en-US" sz="700" dirty="0">
                    <a:latin typeface="Arial" panose="020B0604020202020204" pitchFamily="34" charset="0"/>
                    <a:cs typeface="Arial" panose="020B0604020202020204" pitchFamily="34" charset="0"/>
                  </a:rPr>
                  <a:t>-Fetus</a:t>
                </a:r>
                <a:r>
                  <a:rPr lang="en-US" sz="700" baseline="30000" dirty="0">
                    <a:latin typeface="Arial" panose="020B0604020202020204" pitchFamily="34" charset="0"/>
                    <a:cs typeface="Arial" panose="020B0604020202020204" pitchFamily="34" charset="0"/>
                  </a:rPr>
                  <a:t>m3m4</a:t>
                </a:r>
              </a:p>
            </p:txBody>
          </p:sp>
        </p:grp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8C6761AB-5AB0-BE44-B0C7-3CE8030BCA9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31679" y="472022"/>
            <a:ext cx="1638300" cy="1168400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571C80BC-5C41-A441-AF93-89E9E631940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64335" y="416522"/>
            <a:ext cx="1638300" cy="12319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07B524B-FA86-0147-B159-72FF4585447B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31679" y="1807009"/>
            <a:ext cx="1638300" cy="116840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1254E300-7031-B346-A2C2-B3242528719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138935" y="1808189"/>
            <a:ext cx="1689100" cy="1181100"/>
          </a:xfrm>
          <a:prstGeom prst="rect">
            <a:avLst/>
          </a:prstGeom>
        </p:spPr>
      </p:pic>
      <p:sp>
        <p:nvSpPr>
          <p:cNvPr id="22" name="TextBox 21">
            <a:extLst>
              <a:ext uri="{FF2B5EF4-FFF2-40B4-BE49-F238E27FC236}">
                <a16:creationId xmlns:a16="http://schemas.microsoft.com/office/drawing/2014/main" id="{C94BB47A-1B27-BE43-91AE-66AE9F3C6ADE}"/>
              </a:ext>
            </a:extLst>
          </p:cNvPr>
          <p:cNvSpPr txBox="1"/>
          <p:nvPr/>
        </p:nvSpPr>
        <p:spPr>
          <a:xfrm>
            <a:off x="631679" y="33634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BEE01C56-4F5F-8548-9C1A-71E0E0ACC4B7}"/>
              </a:ext>
            </a:extLst>
          </p:cNvPr>
          <p:cNvSpPr txBox="1"/>
          <p:nvPr/>
        </p:nvSpPr>
        <p:spPr>
          <a:xfrm>
            <a:off x="2159100" y="33641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ECDDFB75-7224-F84E-AE99-63518F675011}"/>
              </a:ext>
            </a:extLst>
          </p:cNvPr>
          <p:cNvSpPr txBox="1"/>
          <p:nvPr/>
        </p:nvSpPr>
        <p:spPr>
          <a:xfrm>
            <a:off x="3575642" y="332717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B4D32D2-F7C3-BB4E-B9B3-28DADF50DD7C}"/>
              </a:ext>
            </a:extLst>
          </p:cNvPr>
          <p:cNvSpPr txBox="1"/>
          <p:nvPr/>
        </p:nvSpPr>
        <p:spPr>
          <a:xfrm>
            <a:off x="631679" y="164842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28B603DE-7CAE-8743-9C8B-9A762C0F154F}"/>
              </a:ext>
            </a:extLst>
          </p:cNvPr>
          <p:cNvSpPr txBox="1"/>
          <p:nvPr/>
        </p:nvSpPr>
        <p:spPr>
          <a:xfrm>
            <a:off x="2159100" y="1648422"/>
            <a:ext cx="304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5FA0F8E-A29A-9E48-AFDA-D216163860C9}"/>
              </a:ext>
            </a:extLst>
          </p:cNvPr>
          <p:cNvSpPr txBox="1"/>
          <p:nvPr/>
        </p:nvSpPr>
        <p:spPr>
          <a:xfrm>
            <a:off x="637740" y="2805319"/>
            <a:ext cx="29367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2017766"/>
              </p:ext>
            </p:extLst>
          </p:nvPr>
        </p:nvGraphicFramePr>
        <p:xfrm>
          <a:off x="3676903" y="265906"/>
          <a:ext cx="1917700" cy="1462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0" name="Prism 9" r:id="rId8" imgW="1918083" imgH="1461791" progId="Prism9.Document">
                  <p:embed/>
                </p:oleObj>
              </mc:Choice>
              <mc:Fallback>
                <p:oleObj name="Prism 9" r:id="rId8" imgW="1918083" imgH="1461791" progId="Prism9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676903" y="265906"/>
                        <a:ext cx="1917700" cy="1462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708910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31</TotalTime>
  <Words>102</Words>
  <Application>Microsoft Macintosh PowerPoint</Application>
  <PresentationFormat>A4 Paper (210x297 mm)</PresentationFormat>
  <Paragraphs>12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rism 9</vt:lpstr>
      <vt:lpstr>PowerPoint Presentation</vt:lpstr>
    </vt:vector>
  </TitlesOfParts>
  <Company>Cleveland Clinic</Company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ini, Ritika</dc:creator>
  <cp:lastModifiedBy>Microsoft Office User</cp:lastModifiedBy>
  <cp:revision>77</cp:revision>
  <cp:lastPrinted>2020-08-18T14:48:40Z</cp:lastPrinted>
  <dcterms:created xsi:type="dcterms:W3CDTF">2020-08-14T21:01:00Z</dcterms:created>
  <dcterms:modified xsi:type="dcterms:W3CDTF">2021-03-10T20:11:38Z</dcterms:modified>
</cp:coreProperties>
</file>